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74" r:id="rId2"/>
    <p:sldId id="947" r:id="rId3"/>
  </p:sldIdLst>
  <p:sldSz cx="6858000" cy="9906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121A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854"/>
    <p:restoredTop sz="94450" autoAdjust="0"/>
  </p:normalViewPr>
  <p:slideViewPr>
    <p:cSldViewPr snapToGrid="0" snapToObjects="1">
      <p:cViewPr varScale="1">
        <p:scale>
          <a:sx n="91" d="100"/>
          <a:sy n="91" d="100"/>
        </p:scale>
        <p:origin x="235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CF04DA-DDEA-B64A-9195-AF6DAEC8E118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3488"/>
            <a:ext cx="23034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FE6749-6D6C-E64E-919B-EA1C26CBD0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8144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FE6749-6D6C-E64E-919B-EA1C26CBD07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96001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FE6749-6D6C-E64E-919B-EA1C26CBD071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30429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B73-74A9-9443-85D9-E971D99CD5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A155E-4C21-C44E-B1F0-49E01B82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6929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B73-74A9-9443-85D9-E971D99CD5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A155E-4C21-C44E-B1F0-49E01B82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4622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B73-74A9-9443-85D9-E971D99CD5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A155E-4C21-C44E-B1F0-49E01B82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9880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B73-74A9-9443-85D9-E971D99CD5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A155E-4C21-C44E-B1F0-49E01B82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3700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B73-74A9-9443-85D9-E971D99CD5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A155E-4C21-C44E-B1F0-49E01B82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2804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B73-74A9-9443-85D9-E971D99CD5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A155E-4C21-C44E-B1F0-49E01B82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65623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B73-74A9-9443-85D9-E971D99CD5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A155E-4C21-C44E-B1F0-49E01B82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35786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B73-74A9-9443-85D9-E971D99CD5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A155E-4C21-C44E-B1F0-49E01B82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3785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B73-74A9-9443-85D9-E971D99CD5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A155E-4C21-C44E-B1F0-49E01B82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4824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B73-74A9-9443-85D9-E971D99CD5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A155E-4C21-C44E-B1F0-49E01B82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173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B73-74A9-9443-85D9-E971D99CD5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A155E-4C21-C44E-B1F0-49E01B82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4637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3C6B73-74A9-9443-85D9-E971D99CD5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1A155E-4C21-C44E-B1F0-49E01B82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7594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98">
            <a:extLst>
              <a:ext uri="{FF2B5EF4-FFF2-40B4-BE49-F238E27FC236}">
                <a16:creationId xmlns:a16="http://schemas.microsoft.com/office/drawing/2014/main" id="{71129D27-934B-408A-AD25-27058F8B6E40}"/>
              </a:ext>
            </a:extLst>
          </p:cNvPr>
          <p:cNvSpPr/>
          <p:nvPr/>
        </p:nvSpPr>
        <p:spPr>
          <a:xfrm>
            <a:off x="4024" y="-1993"/>
            <a:ext cx="4101251" cy="34169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S1 </a:t>
            </a:r>
            <a:endParaRPr lang="ja-JP" altLang="en-US" sz="2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5" name="図 54">
            <a:extLst>
              <a:ext uri="{FF2B5EF4-FFF2-40B4-BE49-F238E27FC236}">
                <a16:creationId xmlns:a16="http://schemas.microsoft.com/office/drawing/2014/main" id="{9783D039-C37F-9FFE-DB6B-D22A803F1E9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2224"/>
          <a:stretch/>
        </p:blipFill>
        <p:spPr>
          <a:xfrm>
            <a:off x="0" y="741886"/>
            <a:ext cx="6852498" cy="6121901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60DBD28-479F-B75A-4761-8961177CB9B5}"/>
              </a:ext>
            </a:extLst>
          </p:cNvPr>
          <p:cNvSpPr txBox="1"/>
          <p:nvPr/>
        </p:nvSpPr>
        <p:spPr>
          <a:xfrm>
            <a:off x="4024" y="6921659"/>
            <a:ext cx="6848474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Group 1, North and Central district; Group 2, South district; Group 3, East district; Group 4, West district; Group 5, North and Central district</a:t>
            </a:r>
          </a:p>
          <a:p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This figure is illustrated manually using Microsoft PowerPoint 2019 MSO (version 2301, Build 16.0.16026.20196) 64 bit (https://www.microsoft.com/en-us/microsoft-365/powerpoint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52660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56B03FE-FFF5-01CB-1A79-6689FEC66084}"/>
              </a:ext>
            </a:extLst>
          </p:cNvPr>
          <p:cNvSpPr txBox="1"/>
          <p:nvPr/>
        </p:nvSpPr>
        <p:spPr>
          <a:xfrm>
            <a:off x="317500" y="774476"/>
            <a:ext cx="6273800" cy="552472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16" name="正方形/長方形 98">
            <a:extLst>
              <a:ext uri="{FF2B5EF4-FFF2-40B4-BE49-F238E27FC236}">
                <a16:creationId xmlns:a16="http://schemas.microsoft.com/office/drawing/2014/main" id="{32F31785-15F2-47D9-BEB3-B15A88C7D077}"/>
              </a:ext>
            </a:extLst>
          </p:cNvPr>
          <p:cNvSpPr/>
          <p:nvPr/>
        </p:nvSpPr>
        <p:spPr>
          <a:xfrm>
            <a:off x="18256" y="-1994"/>
            <a:ext cx="3368328" cy="401599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lang="ja-JP" altLang="en-US" sz="2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図 20">
            <a:extLst>
              <a:ext uri="{FF2B5EF4-FFF2-40B4-BE49-F238E27FC236}">
                <a16:creationId xmlns:a16="http://schemas.microsoft.com/office/drawing/2014/main" id="{C76505DD-D93F-0474-48C6-A3496EC2FD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2336" y="1031685"/>
            <a:ext cx="6273328" cy="55234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19743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64</TotalTime>
  <Words>75</Words>
  <Application>Microsoft Office PowerPoint</Application>
  <PresentationFormat>A4 210 x 297 mm</PresentationFormat>
  <Paragraphs>6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naka</dc:creator>
  <cp:lastModifiedBy>永井　利幸</cp:lastModifiedBy>
  <cp:revision>202</cp:revision>
  <cp:lastPrinted>2022-05-11T11:56:29Z</cp:lastPrinted>
  <dcterms:created xsi:type="dcterms:W3CDTF">2019-07-01T13:17:44Z</dcterms:created>
  <dcterms:modified xsi:type="dcterms:W3CDTF">2023-03-07T23:21:38Z</dcterms:modified>
</cp:coreProperties>
</file>